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1392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3454;&#39564;&#25968;&#25454;\taishi\hhrrc\R%20gene%20distribution\R%20gene%20screening%20results\R%20gene%20sequencing%20resul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3454;&#39564;&#25968;&#25454;\taishi\hhrrc\R%20gene%20distribution\R%20gene%20screening%20results\R%20gene%20sequencing%20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diamond"/>
            <c:size val="7"/>
            <c:spPr>
              <a:solidFill>
                <a:srgbClr val="00B050"/>
              </a:solidFill>
              <a:ln>
                <a:noFill/>
              </a:ln>
            </c:spPr>
          </c:marker>
          <c:yVal>
            <c:numRef>
              <c:f>Sheet5!$E$3:$E$16</c:f>
              <c:numCache>
                <c:formatCode>0.0%</c:formatCode>
                <c:ptCount val="14"/>
                <c:pt idx="0">
                  <c:v>0.62962962962963076</c:v>
                </c:pt>
                <c:pt idx="1">
                  <c:v>0.18518518518518537</c:v>
                </c:pt>
                <c:pt idx="2">
                  <c:v>0.37037037037037107</c:v>
                </c:pt>
                <c:pt idx="3">
                  <c:v>0.48148148148148184</c:v>
                </c:pt>
                <c:pt idx="4">
                  <c:v>0.62962962962963076</c:v>
                </c:pt>
                <c:pt idx="5">
                  <c:v>0.66666666666666663</c:v>
                </c:pt>
                <c:pt idx="6">
                  <c:v>0.59259259259259267</c:v>
                </c:pt>
                <c:pt idx="7">
                  <c:v>0.7407407407407407</c:v>
                </c:pt>
                <c:pt idx="8">
                  <c:v>0.81481481481481544</c:v>
                </c:pt>
                <c:pt idx="9">
                  <c:v>0.2592592592592593</c:v>
                </c:pt>
                <c:pt idx="10">
                  <c:v>0.18518518518518537</c:v>
                </c:pt>
                <c:pt idx="11">
                  <c:v>3.7037037037037056E-2</c:v>
                </c:pt>
                <c:pt idx="12">
                  <c:v>7.407407407407407E-2</c:v>
                </c:pt>
                <c:pt idx="13">
                  <c:v>0.629629629629630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9FB-4D11-996E-1201390CDC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5915264"/>
        <c:axId val="55927168"/>
      </c:scatterChart>
      <c:valAx>
        <c:axId val="55915264"/>
        <c:scaling>
          <c:orientation val="minMax"/>
        </c:scaling>
        <c:delete val="0"/>
        <c:axPos val="b"/>
        <c:majorTickMark val="out"/>
        <c:minorTickMark val="none"/>
        <c:tickLblPos val="nextTo"/>
        <c:crossAx val="55927168"/>
        <c:crosses val="autoZero"/>
        <c:crossBetween val="midCat"/>
      </c:valAx>
      <c:valAx>
        <c:axId val="559271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 sz="1000" b="1" i="0" kern="1200" baseline="0" dirty="0" smtClean="0"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Resistance frequency(%)</a:t>
                </a:r>
                <a:endParaRPr lang="zh-CN" altLang="zh-CN" dirty="0">
                  <a:effectLst/>
                </a:endParaRPr>
              </a:p>
            </c:rich>
          </c:tx>
          <c:layout/>
          <c:overlay val="0"/>
        </c:title>
        <c:numFmt formatCode="0.0%" sourceLinked="1"/>
        <c:majorTickMark val="out"/>
        <c:minorTickMark val="none"/>
        <c:tickLblPos val="nextTo"/>
        <c:txPr>
          <a:bodyPr/>
          <a:lstStyle/>
          <a:p>
            <a:pPr>
              <a:defRPr sz="800" b="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591526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>
              <a:noFill/>
            </a:ln>
          </c:spPr>
          <c:marker>
            <c:symbol val="diamond"/>
            <c:size val="7"/>
            <c:spPr>
              <a:ln>
                <a:noFill/>
              </a:ln>
            </c:spPr>
          </c:marker>
          <c:yVal>
            <c:numRef>
              <c:f>Sheet5!$I$3:$I$42</c:f>
              <c:numCache>
                <c:formatCode>0.0%</c:formatCode>
                <c:ptCount val="40"/>
                <c:pt idx="0">
                  <c:v>0.59259259259259267</c:v>
                </c:pt>
                <c:pt idx="1">
                  <c:v>0.40740740740740738</c:v>
                </c:pt>
                <c:pt idx="2">
                  <c:v>0.77777777777777846</c:v>
                </c:pt>
                <c:pt idx="3">
                  <c:v>0.96296296296296169</c:v>
                </c:pt>
                <c:pt idx="4">
                  <c:v>0.2592592592592593</c:v>
                </c:pt>
                <c:pt idx="5">
                  <c:v>1</c:v>
                </c:pt>
                <c:pt idx="6">
                  <c:v>0.5185185185185186</c:v>
                </c:pt>
                <c:pt idx="7">
                  <c:v>1</c:v>
                </c:pt>
                <c:pt idx="8">
                  <c:v>0.85185185185185253</c:v>
                </c:pt>
                <c:pt idx="9">
                  <c:v>0.29629629629629628</c:v>
                </c:pt>
                <c:pt idx="10">
                  <c:v>0.70370370370370372</c:v>
                </c:pt>
                <c:pt idx="11">
                  <c:v>0.77777777777777846</c:v>
                </c:pt>
                <c:pt idx="12">
                  <c:v>0.48148148148148184</c:v>
                </c:pt>
                <c:pt idx="13">
                  <c:v>1</c:v>
                </c:pt>
                <c:pt idx="14">
                  <c:v>0.66666666666666663</c:v>
                </c:pt>
                <c:pt idx="15">
                  <c:v>0.77777777777777846</c:v>
                </c:pt>
                <c:pt idx="16">
                  <c:v>0.92592592592592549</c:v>
                </c:pt>
                <c:pt idx="17">
                  <c:v>0.22222222222222221</c:v>
                </c:pt>
                <c:pt idx="18">
                  <c:v>0.55555555555555569</c:v>
                </c:pt>
                <c:pt idx="19">
                  <c:v>0.66666666666666663</c:v>
                </c:pt>
                <c:pt idx="20">
                  <c:v>0.40740740740740738</c:v>
                </c:pt>
                <c:pt idx="21">
                  <c:v>0.44444444444444442</c:v>
                </c:pt>
                <c:pt idx="22">
                  <c:v>0.5185185185185186</c:v>
                </c:pt>
                <c:pt idx="23">
                  <c:v>0.29629629629629628</c:v>
                </c:pt>
                <c:pt idx="24">
                  <c:v>0.77777777777777846</c:v>
                </c:pt>
                <c:pt idx="25">
                  <c:v>0.40740740740740738</c:v>
                </c:pt>
                <c:pt idx="26">
                  <c:v>0.48148148148148184</c:v>
                </c:pt>
                <c:pt idx="27">
                  <c:v>0.66666666666666663</c:v>
                </c:pt>
                <c:pt idx="28">
                  <c:v>0.77777777777777846</c:v>
                </c:pt>
                <c:pt idx="29">
                  <c:v>0.92592592592592549</c:v>
                </c:pt>
                <c:pt idx="30">
                  <c:v>0.88888888888888884</c:v>
                </c:pt>
                <c:pt idx="31">
                  <c:v>0.62962962962963076</c:v>
                </c:pt>
                <c:pt idx="32">
                  <c:v>0.40740740740740738</c:v>
                </c:pt>
                <c:pt idx="33">
                  <c:v>1</c:v>
                </c:pt>
                <c:pt idx="34">
                  <c:v>0.33333333333333331</c:v>
                </c:pt>
                <c:pt idx="35">
                  <c:v>0.7407407407407407</c:v>
                </c:pt>
                <c:pt idx="36">
                  <c:v>0.37037037037037107</c:v>
                </c:pt>
                <c:pt idx="37">
                  <c:v>0.62962962962963076</c:v>
                </c:pt>
                <c:pt idx="38">
                  <c:v>0.5185185185185186</c:v>
                </c:pt>
                <c:pt idx="39">
                  <c:v>0.51851851851851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FD3-4568-AF41-FF2D947E97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5991296"/>
        <c:axId val="91190016"/>
      </c:scatterChart>
      <c:valAx>
        <c:axId val="55991296"/>
        <c:scaling>
          <c:orientation val="minMax"/>
        </c:scaling>
        <c:delete val="0"/>
        <c:axPos val="b"/>
        <c:majorTickMark val="out"/>
        <c:minorTickMark val="none"/>
        <c:tickLblPos val="nextTo"/>
        <c:crossAx val="91190016"/>
        <c:crosses val="autoZero"/>
        <c:crossBetween val="midCat"/>
      </c:valAx>
      <c:valAx>
        <c:axId val="91190016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zh-CN" sz="1050" dirty="0" smtClean="0">
                    <a:latin typeface="Times New Roman" pitchFamily="18" charset="0"/>
                    <a:cs typeface="Times New Roman" pitchFamily="18" charset="0"/>
                  </a:rPr>
                  <a:t>Resistance</a:t>
                </a:r>
                <a:r>
                  <a:rPr lang="en-US" altLang="zh-CN" sz="1050" baseline="0" dirty="0" smtClean="0">
                    <a:latin typeface="Times New Roman" pitchFamily="18" charset="0"/>
                    <a:cs typeface="Times New Roman" pitchFamily="18" charset="0"/>
                  </a:rPr>
                  <a:t> frequency(%)</a:t>
                </a:r>
                <a:endParaRPr lang="zh-CN" altLang="en-US" sz="1050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0.0%" sourceLinked="1"/>
        <c:majorTickMark val="out"/>
        <c:minorTickMark val="none"/>
        <c:tickLblPos val="nextTo"/>
        <c:txPr>
          <a:bodyPr/>
          <a:lstStyle/>
          <a:p>
            <a:pPr>
              <a:defRPr sz="800" b="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5991296"/>
        <c:crosses val="autoZero"/>
        <c:crossBetween val="midCat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5047960"/>
              </p:ext>
            </p:extLst>
          </p:nvPr>
        </p:nvGraphicFramePr>
        <p:xfrm>
          <a:off x="98946" y="19653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2273363"/>
              </p:ext>
            </p:extLst>
          </p:nvPr>
        </p:nvGraphicFramePr>
        <p:xfrm>
          <a:off x="4427984" y="1990700"/>
          <a:ext cx="469952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220236" y="1557926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1994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823074" y="147739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2015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823789" y="3112244"/>
            <a:ext cx="35877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5220270" y="3264892"/>
            <a:ext cx="3456186" cy="850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812524" y="2230995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(50%)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199338" y="2269480"/>
            <a:ext cx="7920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(67.5%)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95536" y="5085184"/>
            <a:ext cx="835292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. Resistance frequency of varieties in 1994 (A) and 2015 (B). The resistance frequency listed in Table S3 of each varieties in 1994 and 2015 is plotted. The 50% of frequency is indicated in the red line. Percentage of varieties with </a:t>
            </a:r>
            <a:r>
              <a:rPr lang="en-US" altLang="zh-CN" sz="2000" smtClean="0">
                <a:latin typeface="Times New Roman" pitchFamily="18" charset="0"/>
                <a:cs typeface="Times New Roman" pitchFamily="18" charset="0"/>
              </a:rPr>
              <a:t>no </a:t>
            </a:r>
            <a:r>
              <a:rPr lang="en-US" altLang="zh-CN" sz="2000" smtClean="0">
                <a:latin typeface="Times New Roman" pitchFamily="18" charset="0"/>
                <a:cs typeface="Times New Roman" pitchFamily="18" charset="0"/>
              </a:rPr>
              <a:t>lower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than 50% of resistance frequency in 1994 and 2015 is indicated in parentheses, respectively.  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70017" y="1585521"/>
            <a:ext cx="872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)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506615" y="1585521"/>
            <a:ext cx="872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6205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87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Zhou, Bo (FAORAP)</cp:lastModifiedBy>
  <cp:revision>7</cp:revision>
  <dcterms:modified xsi:type="dcterms:W3CDTF">2019-12-14T16:53:30Z</dcterms:modified>
</cp:coreProperties>
</file>